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59"/>
    <p:restoredTop sz="94694"/>
  </p:normalViewPr>
  <p:slideViewPr>
    <p:cSldViewPr snapToGrid="0" snapToObjects="1">
      <p:cViewPr>
        <p:scale>
          <a:sx n="166" d="100"/>
          <a:sy n="166" d="100"/>
        </p:scale>
        <p:origin x="672" y="-8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78197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39000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787972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19990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0573914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856036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539104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548479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3062060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762123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10582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BFB052-7FD0-C548-80EC-DFA62537916F}" type="datetimeFigureOut">
              <a:rPr kumimoji="1" lang="zh-CN" altLang="en-US" smtClean="0"/>
              <a:t>2019/10/21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31582A-34FD-7B4B-9932-730999CA0BB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846150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图片包含 文字&#10;&#10;描述已自动生成">
            <a:extLst>
              <a:ext uri="{FF2B5EF4-FFF2-40B4-BE49-F238E27FC236}">
                <a16:creationId xmlns:a16="http://schemas.microsoft.com/office/drawing/2014/main" id="{D3B37C13-D3BF-7543-ADF5-CCC390A0DA9D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6554" y="761473"/>
            <a:ext cx="7815274" cy="4118176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CD8A009E-6550-2849-80F6-90E969890A21}"/>
              </a:ext>
            </a:extLst>
          </p:cNvPr>
          <p:cNvSpPr/>
          <p:nvPr/>
        </p:nvSpPr>
        <p:spPr>
          <a:xfrm>
            <a:off x="746554" y="5055715"/>
            <a:ext cx="7815274" cy="144808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  <a:spcAft>
                <a:spcPts val="0"/>
              </a:spcAft>
            </a:pPr>
            <a:r>
              <a:rPr lang="en-US" altLang="zh-CN" sz="1200" b="1" kern="10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Figure 1S  </a:t>
            </a: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Translation of Nucleotides into Amino Acids for Thesis by GENETYX.</a:t>
            </a:r>
            <a:endParaRPr lang="zh-CN" altLang="zh-CN" sz="1200" kern="100" dirty="0"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DengXian" panose="02010600030101010101" pitchFamily="2" charset="-122"/>
                <a:cs typeface="Times New Roman" panose="02020603050405020304" pitchFamily="18" charset="0"/>
              </a:rPr>
              <a:t>A. The partial sequence of wildtype FBN1 protein (2681-2871 amino acid [aa]) were shown. The amino acids underlined in pink represent the loss of the amino acids in corresponding mutant product (p.Glu2759Cysfs*9). B. The partial sequence of mutant FBN1 protein (2681-2767 aa) were shown. The position of 2767 aa with a premature stop codon TAA was marked in pink. </a:t>
            </a:r>
            <a:endParaRPr lang="zh-CN" altLang="zh-CN" sz="12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66013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</TotalTime>
  <Words>88</Words>
  <Application>Microsoft Macintosh PowerPoint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DengXian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ao Lin</dc:creator>
  <cp:lastModifiedBy>Mao Lin</cp:lastModifiedBy>
  <cp:revision>2</cp:revision>
  <dcterms:created xsi:type="dcterms:W3CDTF">2019-10-21T00:02:43Z</dcterms:created>
  <dcterms:modified xsi:type="dcterms:W3CDTF">2019-10-21T00:20:16Z</dcterms:modified>
</cp:coreProperties>
</file>